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27" d="100"/>
          <a:sy n="127" d="100"/>
        </p:scale>
        <p:origin x="512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2B0776-E854-43BF-8DA7-6DB37D8E1BB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09BE0CF-AE23-4E29-9166-A2F30B552FC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8AA816-6EAA-4A24-93FA-718EAF2DFC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6149F-2D5C-425D-8E33-AB7FACB9D174}" type="datetimeFigureOut">
              <a:rPr lang="en-GB" smtClean="0"/>
              <a:t>31/03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9F57BD-BAAF-4464-94DA-06A6DB0EB1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405D43-F64F-4354-9D4F-0CE663AD28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DD5E4-B997-4B0A-9923-81193F7F54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09493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958689-8926-4CE5-AD1A-ED71010813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2695796-54E6-4C9B-A789-66DF4F87577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3A5D42-A86C-4FD3-94E8-58F1B30403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6149F-2D5C-425D-8E33-AB7FACB9D174}" type="datetimeFigureOut">
              <a:rPr lang="en-GB" smtClean="0"/>
              <a:t>31/03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E8D07C-8AAA-449C-B241-0885D9F10B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8D6930-2286-40AC-8068-FDEBE6BAC9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DD5E4-B997-4B0A-9923-81193F7F54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765077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C26B273-2739-42E4-A0F0-EFD2F517660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A512D7E-8F8E-4ED5-B999-FB1BAE29F9C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6EF288-0C96-468F-A45C-F22905DFDE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6149F-2D5C-425D-8E33-AB7FACB9D174}" type="datetimeFigureOut">
              <a:rPr lang="en-GB" smtClean="0"/>
              <a:t>31/03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CF5CE7-662F-4C49-9B06-35E7BB08D6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D3706E5-F31C-459D-B955-566DCBAEBD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DD5E4-B997-4B0A-9923-81193F7F54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11747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990777-6505-4F0F-BCFF-C96E0CA46B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605C13D-2F16-484C-ABFD-CD7F30290B3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8B596A-43CF-4E4E-8029-21A1190800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6149F-2D5C-425D-8E33-AB7FACB9D174}" type="datetimeFigureOut">
              <a:rPr lang="en-GB" smtClean="0"/>
              <a:t>31/03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72441D-1AEE-482E-AEAA-6BCCCBADFE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01A6CB-1D26-4E2F-9DFA-025ACEEDE8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DD5E4-B997-4B0A-9923-81193F7F54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99558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E7D440-C611-4A41-8992-380BB85072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0CA0156-5403-4E8D-9936-E0669E29EA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61C27A-56D3-4961-91D7-96D256C242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6149F-2D5C-425D-8E33-AB7FACB9D174}" type="datetimeFigureOut">
              <a:rPr lang="en-GB" smtClean="0"/>
              <a:t>31/03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926910-112D-404C-832E-13BCC6FF8B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521184-259F-4281-9EB5-F57C937864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DD5E4-B997-4B0A-9923-81193F7F54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00909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C9F15E-DA89-4617-98F2-84208F11A8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ADE7E57-AE5E-48AF-BEE0-1C47C93078B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CF70829-FBF4-432E-8143-687CF9002B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B042A6C-AD86-4764-8575-FBB37F1E5A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6149F-2D5C-425D-8E33-AB7FACB9D174}" type="datetimeFigureOut">
              <a:rPr lang="en-GB" smtClean="0"/>
              <a:t>31/03/2026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40D7A98-8937-495D-8241-DC689E6F0E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7C2DA0E-AE2C-4F6A-8377-0A800B6259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DD5E4-B997-4B0A-9923-81193F7F54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230244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E48A58-2CC1-4D0F-8FC9-2DB8302F47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13141BC-A19C-43D2-BB4B-A36C162464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C9BBD4E-B297-4467-9E27-AC187600927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807EADD-AC35-4A62-942B-A267AA37682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FF3EB2B-5A58-4CEF-9697-8B0F4107633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335C0D8-6105-43F0-AED8-8A444ED064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6149F-2D5C-425D-8E33-AB7FACB9D174}" type="datetimeFigureOut">
              <a:rPr lang="en-GB" smtClean="0"/>
              <a:t>31/03/2026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8D3D881-CA5F-4988-B339-37B4C4C468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49D9068-12DB-4E19-8BA6-B6A77A5F0D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DD5E4-B997-4B0A-9923-81193F7F54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923649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1D2272-2B8C-4BEB-B85F-C8F87F2FCE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666CBA1-8695-40EC-91A0-784D95BA16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6149F-2D5C-425D-8E33-AB7FACB9D174}" type="datetimeFigureOut">
              <a:rPr lang="en-GB" smtClean="0"/>
              <a:t>31/03/2026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BF6FC1B-E2A3-4F20-8C7F-00F7272D68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E080D3D-E79C-4C91-AD16-F9199C0ED0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DD5E4-B997-4B0A-9923-81193F7F54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59404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A42D3F0-27EC-48EB-AF4D-ECBF78FE01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6149F-2D5C-425D-8E33-AB7FACB9D174}" type="datetimeFigureOut">
              <a:rPr lang="en-GB" smtClean="0"/>
              <a:t>31/03/2026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2DE0A2E-9323-459B-B7D1-9D6513C996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455478C-1BF8-48E6-B962-18ED8E74EA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DD5E4-B997-4B0A-9923-81193F7F54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64455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CD26A1-5102-4D59-80E8-81B3AD4A07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5FC3EBC-9841-466E-9EDB-93F96024C75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DA43BA1-481B-4C72-9084-BB5DF2F408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C8557D2-B6EB-4C10-B3AA-5C08155D0F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6149F-2D5C-425D-8E33-AB7FACB9D174}" type="datetimeFigureOut">
              <a:rPr lang="en-GB" smtClean="0"/>
              <a:t>31/03/2026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F326DBD-ACCE-4564-B4A0-5B845CED11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05843A6-93B0-42F9-A803-9B429175FC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DD5E4-B997-4B0A-9923-81193F7F54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82093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83F332-1574-4FA5-BB31-FC9717D6B0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CFA6FDA-08E3-4941-9A7B-AF9257530FE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8A498E8-1AB1-4030-91BF-3F76556C12F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AC8871C-D21C-4C38-94FF-DEEAF5A526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6149F-2D5C-425D-8E33-AB7FACB9D174}" type="datetimeFigureOut">
              <a:rPr lang="en-GB" smtClean="0"/>
              <a:t>31/03/2026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3785313-97D6-4E7F-8F34-1C82F519A8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E2B1982-9C40-4B9F-B3B3-D1AF7075ED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DD5E4-B997-4B0A-9923-81193F7F54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82156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46CFE34-8586-4B86-B567-C5FFE01D90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6CEB4B5-05B0-4BEE-AC2D-B7EFEF46B4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5AF742-C85E-46A4-A7BB-C843C0CC027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76149F-2D5C-425D-8E33-AB7FACB9D174}" type="datetimeFigureOut">
              <a:rPr lang="en-GB" smtClean="0"/>
              <a:t>31/03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F231D0-BB2B-4AB1-82D5-CFB1E2064B5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A6D2752-9819-4FBC-829C-4A03B91731E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EDD5E4-B997-4B0A-9923-81193F7F54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596464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1DBA6ADC-F5A6-4D1E-9C95-50FA9E68E8A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79848134"/>
              </p:ext>
            </p:extLst>
          </p:nvPr>
        </p:nvGraphicFramePr>
        <p:xfrm>
          <a:off x="4403558" y="1778161"/>
          <a:ext cx="5035193" cy="238903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5657732" imgH="2684948" progId="Prism8.Document">
                  <p:embed/>
                </p:oleObj>
              </mc:Choice>
              <mc:Fallback>
                <p:oleObj name="Prism 8" r:id="rId2" imgW="5657732" imgH="2684948" progId="Prism8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1DBA6ADC-F5A6-4D1E-9C95-50FA9E68E8A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403558" y="1778161"/>
                        <a:ext cx="5035193" cy="238903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3" name="Group 2">
            <a:extLst>
              <a:ext uri="{FF2B5EF4-FFF2-40B4-BE49-F238E27FC236}">
                <a16:creationId xmlns:a16="http://schemas.microsoft.com/office/drawing/2014/main" id="{E8495CA5-891C-4F01-AF58-0CD6521EAB60}"/>
              </a:ext>
            </a:extLst>
          </p:cNvPr>
          <p:cNvGrpSpPr/>
          <p:nvPr/>
        </p:nvGrpSpPr>
        <p:grpSpPr>
          <a:xfrm>
            <a:off x="549442" y="1631173"/>
            <a:ext cx="3854116" cy="2683008"/>
            <a:chOff x="549442" y="1600234"/>
            <a:chExt cx="5915526" cy="4046587"/>
          </a:xfrm>
        </p:grpSpPr>
        <p:pic>
          <p:nvPicPr>
            <p:cNvPr id="6" name="Picture 5" descr="A picture containing indoor, plastic&#10;&#10;Description automatically generated">
              <a:extLst>
                <a:ext uri="{FF2B5EF4-FFF2-40B4-BE49-F238E27FC236}">
                  <a16:creationId xmlns:a16="http://schemas.microsoft.com/office/drawing/2014/main" id="{EC174247-9980-4E9B-BD3A-C96988799721}"/>
                </a:ext>
              </a:extLst>
            </p:cNvPr>
            <p:cNvPicPr/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642" t="7228" r="22542" b="4823"/>
            <a:stretch/>
          </p:blipFill>
          <p:spPr bwMode="auto">
            <a:xfrm rot="10800000">
              <a:off x="3547231" y="1600234"/>
              <a:ext cx="2917737" cy="4046586"/>
            </a:xfrm>
            <a:prstGeom prst="rect">
              <a:avLst/>
            </a:prstGeom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193AE235-3D2B-4738-B2C8-7C601F093B43}"/>
                </a:ext>
              </a:extLst>
            </p:cNvPr>
            <p:cNvGrpSpPr/>
            <p:nvPr/>
          </p:nvGrpSpPr>
          <p:grpSpPr>
            <a:xfrm>
              <a:off x="549442" y="1600234"/>
              <a:ext cx="2859505" cy="4046587"/>
              <a:chOff x="549442" y="1600234"/>
              <a:chExt cx="3491230" cy="4837430"/>
            </a:xfrm>
          </p:grpSpPr>
          <p:pic>
            <p:nvPicPr>
              <p:cNvPr id="5" name="Picture 4" descr="A picture containing indoor, white, grater, plastic&#10;&#10;Description automatically generated">
                <a:extLst>
                  <a:ext uri="{FF2B5EF4-FFF2-40B4-BE49-F238E27FC236}">
                    <a16:creationId xmlns:a16="http://schemas.microsoft.com/office/drawing/2014/main" id="{B16F01A0-A84D-4011-80AA-FAB46CACD92D}"/>
                  </a:ext>
                </a:extLst>
              </p:cNvPr>
              <p:cNvPicPr/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7505" t="8272" r="26776" b="7257"/>
              <a:stretch/>
            </p:blipFill>
            <p:spPr bwMode="auto">
              <a:xfrm rot="10800000">
                <a:off x="549442" y="1600234"/>
                <a:ext cx="3491230" cy="4837430"/>
              </a:xfrm>
              <a:prstGeom prst="rect">
                <a:avLst/>
              </a:prstGeom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sp>
            <p:nvSpPr>
              <p:cNvPr id="7" name="Rectangle: Rounded Corners 6">
                <a:extLst>
                  <a:ext uri="{FF2B5EF4-FFF2-40B4-BE49-F238E27FC236}">
                    <a16:creationId xmlns:a16="http://schemas.microsoft.com/office/drawing/2014/main" id="{8636C6F3-2D73-4873-9F3B-93E4BF7B3746}"/>
                  </a:ext>
                </a:extLst>
              </p:cNvPr>
              <p:cNvSpPr/>
              <p:nvPr/>
            </p:nvSpPr>
            <p:spPr>
              <a:xfrm>
                <a:off x="697832" y="2133600"/>
                <a:ext cx="3159123" cy="697832"/>
              </a:xfrm>
              <a:prstGeom prst="round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8" name="Rectangle: Rounded Corners 7">
                <a:extLst>
                  <a:ext uri="{FF2B5EF4-FFF2-40B4-BE49-F238E27FC236}">
                    <a16:creationId xmlns:a16="http://schemas.microsoft.com/office/drawing/2014/main" id="{6E3D7736-6189-43D9-95D9-23BDAA6476F0}"/>
                  </a:ext>
                </a:extLst>
              </p:cNvPr>
              <p:cNvSpPr/>
              <p:nvPr/>
            </p:nvSpPr>
            <p:spPr>
              <a:xfrm>
                <a:off x="660141" y="4981074"/>
                <a:ext cx="3159123" cy="489284"/>
              </a:xfrm>
              <a:prstGeom prst="round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10" name="Rectangle: Rounded Corners 9">
              <a:extLst>
                <a:ext uri="{FF2B5EF4-FFF2-40B4-BE49-F238E27FC236}">
                  <a16:creationId xmlns:a16="http://schemas.microsoft.com/office/drawing/2014/main" id="{C2232D8C-3F25-4CFC-A070-DBC6F57094A2}"/>
                </a:ext>
              </a:extLst>
            </p:cNvPr>
            <p:cNvSpPr/>
            <p:nvPr/>
          </p:nvSpPr>
          <p:spPr>
            <a:xfrm>
              <a:off x="3700958" y="1950151"/>
              <a:ext cx="2587492" cy="376457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1" name="Rectangle: Rounded Corners 10">
              <a:extLst>
                <a:ext uri="{FF2B5EF4-FFF2-40B4-BE49-F238E27FC236}">
                  <a16:creationId xmlns:a16="http://schemas.microsoft.com/office/drawing/2014/main" id="{B292FE6A-6139-4F6B-B596-DED0D7D6E099}"/>
                </a:ext>
              </a:extLst>
            </p:cNvPr>
            <p:cNvSpPr/>
            <p:nvPr/>
          </p:nvSpPr>
          <p:spPr>
            <a:xfrm>
              <a:off x="3712353" y="3610257"/>
              <a:ext cx="2587492" cy="1547280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12" name="TextBox 11">
            <a:extLst>
              <a:ext uri="{FF2B5EF4-FFF2-40B4-BE49-F238E27FC236}">
                <a16:creationId xmlns:a16="http://schemas.microsoft.com/office/drawing/2014/main" id="{A4CE782B-1FAC-4506-8F67-3F3328F8E042}"/>
              </a:ext>
            </a:extLst>
          </p:cNvPr>
          <p:cNvSpPr txBox="1"/>
          <p:nvPr/>
        </p:nvSpPr>
        <p:spPr>
          <a:xfrm>
            <a:off x="477253" y="4302067"/>
            <a:ext cx="11897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data gathered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40E16F97-610C-4003-8B11-7F7AAC0B47B6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r="41769"/>
          <a:stretch/>
        </p:blipFill>
        <p:spPr>
          <a:xfrm>
            <a:off x="9299921" y="1826718"/>
            <a:ext cx="2342637" cy="2291918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6EC55808-31D1-45BA-8C56-435614815350}"/>
              </a:ext>
            </a:extLst>
          </p:cNvPr>
          <p:cNvSpPr txBox="1"/>
          <p:nvPr/>
        </p:nvSpPr>
        <p:spPr>
          <a:xfrm>
            <a:off x="477253" y="4783674"/>
            <a:ext cx="1116530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4. </a:t>
            </a:r>
            <a:r>
              <a:rPr lang="en-GB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KlCAB2p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drives low amplitude expression of consistent phasing in Arabidopsis, independently of </a:t>
            </a:r>
            <a:r>
              <a:rPr lang="en-GB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AtCAB2::LUC+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Eight wells containing ~10 Arabidopsis seedlings expressing three independent lines of </a:t>
            </a:r>
            <a:r>
              <a:rPr lang="en-GB" sz="1200" i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Kl</a:t>
            </a:r>
            <a:r>
              <a:rPr lang="en-GB" sz="12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CAB2p::LUC+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and </a:t>
            </a:r>
            <a:r>
              <a:rPr lang="en-GB" sz="12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KlTOC1p::LUC+ (K. </a:t>
            </a:r>
            <a:r>
              <a:rPr lang="en-GB" sz="12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laxiflora</a:t>
            </a:r>
            <a:r>
              <a:rPr lang="en-GB" sz="12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romoter region of core clock gene TIMING OF CAB EXPRESSION 1) were imaged under LL for 7-days at 15˚C.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(A) 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Plate layout for experiment, showing all the seedlings imaged during this run, </a:t>
            </a:r>
            <a:r>
              <a:rPr lang="en-GB" sz="12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AtCAB2p::LUC+ 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was not present. </a:t>
            </a:r>
            <a:r>
              <a:rPr lang="en-GB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(B) 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Mean LUC+ expression from ZT24 – ZT102 .</a:t>
            </a:r>
            <a:r>
              <a:rPr lang="en-GB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(</a:t>
            </a:r>
            <a:r>
              <a:rPr lang="en-GB" sz="1200" b="1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</a:rPr>
              <a:t>C</a:t>
            </a:r>
            <a:r>
              <a:rPr lang="en-GB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) 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Mean LUC+ expression from ZT0 – ZT24</a:t>
            </a:r>
            <a:r>
              <a:rPr lang="en-GB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. 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4788CAE-6770-424C-BA51-F46B29556D33}"/>
              </a:ext>
            </a:extLst>
          </p:cNvPr>
          <p:cNvSpPr txBox="1"/>
          <p:nvPr/>
        </p:nvSpPr>
        <p:spPr>
          <a:xfrm>
            <a:off x="459347" y="1315036"/>
            <a:ext cx="93410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A.                                                                  B.                                                                                  C.</a:t>
            </a:r>
          </a:p>
        </p:txBody>
      </p:sp>
    </p:spTree>
    <p:extLst>
      <p:ext uri="{BB962C8B-B14F-4D97-AF65-F5344CB8AC3E}">
        <p14:creationId xmlns:p14="http://schemas.microsoft.com/office/powerpoint/2010/main" val="41945106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0</TotalTime>
  <Words>127</Words>
  <Application>Microsoft Macintosh PowerPoint</Application>
  <PresentationFormat>Widescreen</PresentationFormat>
  <Paragraphs>3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8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figure 5</dc:title>
  <dc:creator>Jessica Pritchard</dc:creator>
  <cp:lastModifiedBy>Hartwell, James</cp:lastModifiedBy>
  <cp:revision>4</cp:revision>
  <dcterms:created xsi:type="dcterms:W3CDTF">2026-03-06T14:49:27Z</dcterms:created>
  <dcterms:modified xsi:type="dcterms:W3CDTF">2026-03-31T17:16:26Z</dcterms:modified>
</cp:coreProperties>
</file>